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FF2FD9-74BE-3642-9B52-D99204E7D19E}" type="datetimeFigureOut">
              <a:rPr lang="en-US" smtClean="0"/>
              <a:t>11/2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F155CF-A796-E641-86C8-EC090139F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30358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7D6A1FE-1F75-4D40-A962-0382E2FEC68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2495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10A52C-FD73-6EE6-A9ED-4395F940DD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E21060D-2D68-C515-5EA0-34DBD995646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C0525C-4908-DB2E-4F87-B4EF1411E1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5A1A0-1A62-9E4D-AE89-ACEAA4B48217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9875C7-C60A-BA5B-DE01-3007219259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2B0EB2-A3F2-F8AF-5272-7A344536A0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1C45F-AB66-7E48-9FFC-42225D95CA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284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9E4E93-70A3-874D-482D-4F85B6AA06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4E54895-38B7-B1F2-F27E-1C5E3B29A3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D8BE58-A0C3-8D0B-C35D-7063B7D3FD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5A1A0-1A62-9E4D-AE89-ACEAA4B48217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044655-7CA0-0787-4BA3-4755096325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685CF8-5BF9-0366-1F78-EC8ECEF224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1C45F-AB66-7E48-9FFC-42225D95CA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176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2BFF4D4-C9E9-F370-040F-2A2F1EBA2DA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39F4CF6-7173-2580-78EC-87FF23FC2C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CB1913-0B58-9F27-976C-49A5CD0C22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5A1A0-1A62-9E4D-AE89-ACEAA4B48217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8BB7BA-8BD6-D028-7F8B-545B09F252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0BA79D-63C6-1BB3-20A3-EC7DFF724A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1C45F-AB66-7E48-9FFC-42225D95CA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85547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D39735-2348-FE05-A71C-46FCBE5FE0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C7D6FE-B020-22B1-BED0-BD7BF2309F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A97832-E442-FC25-4865-B030D8924B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5A1A0-1A62-9E4D-AE89-ACEAA4B48217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6B494E-72E3-9AFF-E7DA-C2E3F01CB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27853B-3793-227B-D51B-8FF6F67D70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1C45F-AB66-7E48-9FFC-42225D95CA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46092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286329-4F88-86C5-1C22-2132F518C1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5D1377-372D-6580-B5C5-1B951BF9A5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BFACA3-1142-DCA5-187D-11105B77E3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5A1A0-1A62-9E4D-AE89-ACEAA4B48217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A19F79-4691-3103-3C64-1D4DB69FA0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F7501C-EBC5-51B8-A9A9-6C826B2CF6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1C45F-AB66-7E48-9FFC-42225D95CA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0418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5F62D2-31B7-17D1-C7D6-2570B67420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8BA64F-F806-B928-523D-476E261FEDF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01D692D-504C-5976-7908-7791AF687C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5ACCA6-EA0F-1E00-A995-CE4D5A32AB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5A1A0-1A62-9E4D-AE89-ACEAA4B48217}" type="datetimeFigureOut">
              <a:rPr lang="en-US" smtClean="0"/>
              <a:t>11/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CA23B6-F839-33E8-9E66-8F69FFD5FA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60AC23-5F54-0370-875C-03E79AA29E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1C45F-AB66-7E48-9FFC-42225D95CA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487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573DDE-6151-CCFD-DF6F-13B2B0929D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47B820-7E1A-7832-9FD5-F8A499BAD1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4D19E52-D103-282C-64EB-3A715F9D04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6D5AFBF-6538-31F9-6CA8-58AF2232CB8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EA8D04E-2FBD-88A0-853D-7246F058DF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7CA9432-6EF2-B81A-3845-821C7978F5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5A1A0-1A62-9E4D-AE89-ACEAA4B48217}" type="datetimeFigureOut">
              <a:rPr lang="en-US" smtClean="0"/>
              <a:t>11/2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78992E6-D02F-84B3-A2C1-69625E1D7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6F05F4E-EB52-18CB-B2B8-99664404B1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1C45F-AB66-7E48-9FFC-42225D95CA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2598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A9D4A8-9A87-05C4-3B8E-AE56FC0D70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C76B02A-79C9-32C6-641F-158B48A4D5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5A1A0-1A62-9E4D-AE89-ACEAA4B48217}" type="datetimeFigureOut">
              <a:rPr lang="en-US" smtClean="0"/>
              <a:t>11/2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0D101CA-E922-DBD5-5849-DA51E6ADA6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C3C425D-4D64-C86A-9DA6-08079695C1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1C45F-AB66-7E48-9FFC-42225D95CA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8709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9B8E39C-7ADD-6D2B-64DD-54A5D30FF8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5A1A0-1A62-9E4D-AE89-ACEAA4B48217}" type="datetimeFigureOut">
              <a:rPr lang="en-US" smtClean="0"/>
              <a:t>11/2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F48C544-D84E-72BC-CC91-2CEBB4E180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FCA7CA4-DC9E-BAED-AC08-EBF643E761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1C45F-AB66-7E48-9FFC-42225D95CA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396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897C9D-D451-0B2B-22D6-7CDB17286D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4F9146-A045-D420-151A-600233CA553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7EE26FA-C8F3-AC1E-ADF8-E76B55E542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13AA7B-B2F9-24F9-61E8-221F990A0B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5A1A0-1A62-9E4D-AE89-ACEAA4B48217}" type="datetimeFigureOut">
              <a:rPr lang="en-US" smtClean="0"/>
              <a:t>11/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01C2FE0-C485-23A4-8172-4CB02820B4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D625B5-5999-DA2F-2049-248BDECD5D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1C45F-AB66-7E48-9FFC-42225D95CA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9806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2788E6-B85C-C901-B26E-C283375C40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9646DEB-4AE1-7885-6836-54F36876C82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B893A7-0475-4E6F-D004-CED3EC00CB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5AD0AC-3F38-BB21-0FD2-59751DB771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5A1A0-1A62-9E4D-AE89-ACEAA4B48217}" type="datetimeFigureOut">
              <a:rPr lang="en-US" smtClean="0"/>
              <a:t>11/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D79E35-7D3C-190A-9F77-79DA03E0D9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7FD737-C7F0-88A0-D591-7CB9C61AB5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1C45F-AB66-7E48-9FFC-42225D95CA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66680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A1985BF-367B-730B-5B30-B26082C87E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49B82A-B753-38BF-B310-2F8B535024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C6C02B-0973-C430-4C44-5F7098FE22A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B5A1A0-1A62-9E4D-AE89-ACEAA4B48217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9FEB6D-6947-0F29-FCB2-EA4ACAEEC43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E33307-3FCA-CC16-88B7-C843CC04711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B1C45F-AB66-7E48-9FFC-42225D95CA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7809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94B24EF6-C8EE-955B-E0AD-E179A46703AC}"/>
              </a:ext>
            </a:extLst>
          </p:cNvPr>
          <p:cNvGrpSpPr/>
          <p:nvPr/>
        </p:nvGrpSpPr>
        <p:grpSpPr>
          <a:xfrm>
            <a:off x="2014073" y="590755"/>
            <a:ext cx="7869512" cy="356827"/>
            <a:chOff x="1866929" y="590755"/>
            <a:chExt cx="7869512" cy="356827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E2464B4-22AB-65AA-8798-BE972FA2DBEE}"/>
                </a:ext>
              </a:extLst>
            </p:cNvPr>
            <p:cNvSpPr txBox="1"/>
            <p:nvPr/>
          </p:nvSpPr>
          <p:spPr>
            <a:xfrm>
              <a:off x="1866929" y="590755"/>
              <a:ext cx="52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2A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C6EB8F5-7B84-B4C9-9DE3-2217E4D743AD}"/>
                </a:ext>
              </a:extLst>
            </p:cNvPr>
            <p:cNvSpPr txBox="1"/>
            <p:nvPr/>
          </p:nvSpPr>
          <p:spPr>
            <a:xfrm>
              <a:off x="5274883" y="596420"/>
              <a:ext cx="52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2B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4D0DF5E0-7C51-8B9B-2799-3A18FD6AC92C}"/>
                </a:ext>
              </a:extLst>
            </p:cNvPr>
            <p:cNvSpPr txBox="1"/>
            <p:nvPr/>
          </p:nvSpPr>
          <p:spPr>
            <a:xfrm>
              <a:off x="9324149" y="639805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3</a:t>
              </a:r>
            </a:p>
          </p:txBody>
        </p:sp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0243FE28-27F8-3AB4-2FFA-8E0BFA1B124F}"/>
              </a:ext>
            </a:extLst>
          </p:cNvPr>
          <p:cNvSpPr txBox="1"/>
          <p:nvPr/>
        </p:nvSpPr>
        <p:spPr>
          <a:xfrm>
            <a:off x="2014073" y="3498080"/>
            <a:ext cx="4122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/>
              <a:t>H4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EE8FFB6-C0CD-6C3E-1607-309C03857097}"/>
              </a:ext>
            </a:extLst>
          </p:cNvPr>
          <p:cNvSpPr txBox="1"/>
          <p:nvPr/>
        </p:nvSpPr>
        <p:spPr>
          <a:xfrm>
            <a:off x="5507962" y="3493485"/>
            <a:ext cx="7088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/>
              <a:t>H3/H4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654D81F-B43E-8460-F937-85257C94D444}"/>
              </a:ext>
            </a:extLst>
          </p:cNvPr>
          <p:cNvSpPr txBox="1"/>
          <p:nvPr/>
        </p:nvSpPr>
        <p:spPr>
          <a:xfrm>
            <a:off x="9097314" y="3532780"/>
            <a:ext cx="11300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/>
              <a:t>MacroH2A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93F8EBA-61DC-5696-9FC2-BE6F6FEFF64F}"/>
              </a:ext>
            </a:extLst>
          </p:cNvPr>
          <p:cNvSpPr txBox="1"/>
          <p:nvPr/>
        </p:nvSpPr>
        <p:spPr>
          <a:xfrm>
            <a:off x="4792424" y="51720"/>
            <a:ext cx="20193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/>
              <a:t>Histones vs Gender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12C08BA-37B8-D107-6B4D-4F6113B75016}"/>
              </a:ext>
            </a:extLst>
          </p:cNvPr>
          <p:cNvSpPr txBox="1"/>
          <p:nvPr/>
        </p:nvSpPr>
        <p:spPr>
          <a:xfrm>
            <a:off x="3298884" y="636227"/>
            <a:ext cx="4235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al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416854A-8FD6-CAE9-BCA8-A0E6B389356B}"/>
              </a:ext>
            </a:extLst>
          </p:cNvPr>
          <p:cNvSpPr txBox="1"/>
          <p:nvPr/>
        </p:nvSpPr>
        <p:spPr>
          <a:xfrm>
            <a:off x="1890324" y="2887930"/>
            <a:ext cx="6351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AF Statu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6FC25DA-22F3-7FF0-C863-C03D0EB95128}"/>
              </a:ext>
            </a:extLst>
          </p:cNvPr>
          <p:cNvSpPr txBox="1"/>
          <p:nvPr/>
        </p:nvSpPr>
        <p:spPr>
          <a:xfrm>
            <a:off x="1041705" y="2884387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CDFABB3-AC32-AEAD-D0B5-EB5A6B6B1337}"/>
              </a:ext>
            </a:extLst>
          </p:cNvPr>
          <p:cNvSpPr txBox="1"/>
          <p:nvPr/>
        </p:nvSpPr>
        <p:spPr>
          <a:xfrm>
            <a:off x="2814899" y="2855814"/>
            <a:ext cx="654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</a:p>
          <a:p>
            <a:endParaRPr lang="en-US" sz="900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46D46B1E-4B83-F114-1BE9-B223BD9246CB}"/>
              </a:ext>
            </a:extLst>
          </p:cNvPr>
          <p:cNvSpPr/>
          <p:nvPr/>
        </p:nvSpPr>
        <p:spPr>
          <a:xfrm>
            <a:off x="3195909" y="573260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FFBE23DA-78F4-C563-5866-F2F0F9ACEB12}"/>
              </a:ext>
            </a:extLst>
          </p:cNvPr>
          <p:cNvSpPr/>
          <p:nvPr/>
        </p:nvSpPr>
        <p:spPr>
          <a:xfrm>
            <a:off x="3195909" y="709416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2DD4ED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6C2AC2C-341F-207B-313C-BA9A8C584B69}"/>
              </a:ext>
            </a:extLst>
          </p:cNvPr>
          <p:cNvSpPr txBox="1"/>
          <p:nvPr/>
        </p:nvSpPr>
        <p:spPr>
          <a:xfrm rot="16200000">
            <a:off x="370328" y="1795083"/>
            <a:ext cx="3946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2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FCA632A-A7F4-5953-0875-FD223BE23786}"/>
              </a:ext>
            </a:extLst>
          </p:cNvPr>
          <p:cNvSpPr txBox="1"/>
          <p:nvPr/>
        </p:nvSpPr>
        <p:spPr>
          <a:xfrm>
            <a:off x="3299612" y="499678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Female</a:t>
            </a:r>
          </a:p>
        </p:txBody>
      </p:sp>
      <p:pic>
        <p:nvPicPr>
          <p:cNvPr id="21" name="Content Placeholder 5">
            <a:extLst>
              <a:ext uri="{FF2B5EF4-FFF2-40B4-BE49-F238E27FC236}">
                <a16:creationId xmlns:a16="http://schemas.microsoft.com/office/drawing/2014/main" id="{50741C9C-B5CB-2DDA-E6B0-1317DE71502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7" r="9776" b="7713"/>
          <a:stretch/>
        </p:blipFill>
        <p:spPr>
          <a:xfrm>
            <a:off x="683074" y="930006"/>
            <a:ext cx="3189931" cy="1946505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5B1D711D-D6E6-EF3C-A8AD-CB1451AA722C}"/>
              </a:ext>
            </a:extLst>
          </p:cNvPr>
          <p:cNvSpPr txBox="1"/>
          <p:nvPr/>
        </p:nvSpPr>
        <p:spPr>
          <a:xfrm>
            <a:off x="6804108" y="644103"/>
            <a:ext cx="4235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al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82D3D2C-1FCB-C002-63BA-A37537A08B98}"/>
              </a:ext>
            </a:extLst>
          </p:cNvPr>
          <p:cNvSpPr txBox="1"/>
          <p:nvPr/>
        </p:nvSpPr>
        <p:spPr>
          <a:xfrm>
            <a:off x="5395548" y="2895806"/>
            <a:ext cx="6351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AF Status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5CC1C53-25B6-AB2C-B676-7EE2BBBAB9BA}"/>
              </a:ext>
            </a:extLst>
          </p:cNvPr>
          <p:cNvSpPr txBox="1"/>
          <p:nvPr/>
        </p:nvSpPr>
        <p:spPr>
          <a:xfrm>
            <a:off x="4546929" y="2892263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18FC1B0-4C9D-8B6C-DFE7-25E679EE7E44}"/>
              </a:ext>
            </a:extLst>
          </p:cNvPr>
          <p:cNvSpPr txBox="1"/>
          <p:nvPr/>
        </p:nvSpPr>
        <p:spPr>
          <a:xfrm>
            <a:off x="6320123" y="2863690"/>
            <a:ext cx="654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</a:p>
          <a:p>
            <a:endParaRPr lang="en-US" sz="900" dirty="0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0706D6E0-3D06-E89C-F2FC-7BBC90944CF6}"/>
              </a:ext>
            </a:extLst>
          </p:cNvPr>
          <p:cNvSpPr/>
          <p:nvPr/>
        </p:nvSpPr>
        <p:spPr>
          <a:xfrm>
            <a:off x="6701133" y="581136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722F17EB-B510-9174-D04A-0531DEAD0164}"/>
              </a:ext>
            </a:extLst>
          </p:cNvPr>
          <p:cNvSpPr/>
          <p:nvPr/>
        </p:nvSpPr>
        <p:spPr>
          <a:xfrm>
            <a:off x="6701133" y="717292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2DD4ED"/>
              </a:solidFill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9C3DCAE-B91D-D709-6DA1-A95BD38BAB4D}"/>
              </a:ext>
            </a:extLst>
          </p:cNvPr>
          <p:cNvSpPr txBox="1"/>
          <p:nvPr/>
        </p:nvSpPr>
        <p:spPr>
          <a:xfrm rot="16200000">
            <a:off x="3874751" y="1802959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2B</a:t>
            </a:r>
          </a:p>
        </p:txBody>
      </p:sp>
      <p:pic>
        <p:nvPicPr>
          <p:cNvPr id="37" name="Picture 36">
            <a:extLst>
              <a:ext uri="{FF2B5EF4-FFF2-40B4-BE49-F238E27FC236}">
                <a16:creationId xmlns:a16="http://schemas.microsoft.com/office/drawing/2014/main" id="{EA1D0F07-2EB9-51CA-872E-647BB0DCB24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0" t="-933" r="10512" b="5109"/>
          <a:stretch/>
        </p:blipFill>
        <p:spPr>
          <a:xfrm>
            <a:off x="4152115" y="917845"/>
            <a:ext cx="3164661" cy="1946232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208DC1A8-4CD8-103D-4A5E-C2F1EB477B69}"/>
              </a:ext>
            </a:extLst>
          </p:cNvPr>
          <p:cNvSpPr txBox="1"/>
          <p:nvPr/>
        </p:nvSpPr>
        <p:spPr>
          <a:xfrm>
            <a:off x="6815114" y="499678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Female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E79F486-4F59-48FF-EDD1-003033B8417C}"/>
              </a:ext>
            </a:extLst>
          </p:cNvPr>
          <p:cNvSpPr txBox="1"/>
          <p:nvPr/>
        </p:nvSpPr>
        <p:spPr>
          <a:xfrm>
            <a:off x="10500848" y="663931"/>
            <a:ext cx="4235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ale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D59F057-2315-0A12-A429-662C23BBB8F7}"/>
              </a:ext>
            </a:extLst>
          </p:cNvPr>
          <p:cNvSpPr txBox="1"/>
          <p:nvPr/>
        </p:nvSpPr>
        <p:spPr>
          <a:xfrm>
            <a:off x="9220122" y="2925064"/>
            <a:ext cx="6351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AF Status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CB25C1F-6CA6-4170-029B-3D81007109CF}"/>
              </a:ext>
            </a:extLst>
          </p:cNvPr>
          <p:cNvSpPr txBox="1"/>
          <p:nvPr/>
        </p:nvSpPr>
        <p:spPr>
          <a:xfrm>
            <a:off x="8477776" y="2925064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BA2D43D-E297-205B-12C1-C704FFF26D34}"/>
              </a:ext>
            </a:extLst>
          </p:cNvPr>
          <p:cNvSpPr txBox="1"/>
          <p:nvPr/>
        </p:nvSpPr>
        <p:spPr>
          <a:xfrm>
            <a:off x="10080668" y="2914772"/>
            <a:ext cx="654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</a:p>
          <a:p>
            <a:endParaRPr lang="en-US" sz="900" dirty="0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3975E57A-1711-4CCA-3023-E0A0AC6F3189}"/>
              </a:ext>
            </a:extLst>
          </p:cNvPr>
          <p:cNvSpPr/>
          <p:nvPr/>
        </p:nvSpPr>
        <p:spPr>
          <a:xfrm>
            <a:off x="10381215" y="614966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89D0B074-3D12-FB64-706A-40E57EC8872C}"/>
              </a:ext>
            </a:extLst>
          </p:cNvPr>
          <p:cNvSpPr/>
          <p:nvPr/>
        </p:nvSpPr>
        <p:spPr>
          <a:xfrm>
            <a:off x="10381215" y="751122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2DD4ED"/>
              </a:solidFill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2A3B90A-02D4-D5D1-4C09-2246AD342695}"/>
              </a:ext>
            </a:extLst>
          </p:cNvPr>
          <p:cNvSpPr txBox="1"/>
          <p:nvPr/>
        </p:nvSpPr>
        <p:spPr>
          <a:xfrm rot="16200000">
            <a:off x="7668378" y="1837423"/>
            <a:ext cx="3273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3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9575AB7-7C0D-FD13-B89E-575BF819C8FD}"/>
              </a:ext>
            </a:extLst>
          </p:cNvPr>
          <p:cNvSpPr txBox="1"/>
          <p:nvPr/>
        </p:nvSpPr>
        <p:spPr>
          <a:xfrm>
            <a:off x="10494088" y="544601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Female</a:t>
            </a:r>
          </a:p>
        </p:txBody>
      </p:sp>
      <p:pic>
        <p:nvPicPr>
          <p:cNvPr id="48" name="Content Placeholder 6">
            <a:extLst>
              <a:ext uri="{FF2B5EF4-FFF2-40B4-BE49-F238E27FC236}">
                <a16:creationId xmlns:a16="http://schemas.microsoft.com/office/drawing/2014/main" id="{4B2B9A0B-85D1-9407-8AC3-7E7AB8B3E30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41" r="12001" b="7541"/>
          <a:stretch/>
        </p:blipFill>
        <p:spPr>
          <a:xfrm>
            <a:off x="7919453" y="943728"/>
            <a:ext cx="3246391" cy="1984950"/>
          </a:xfrm>
          <a:prstGeom prst="rect">
            <a:avLst/>
          </a:prstGeom>
        </p:spPr>
      </p:pic>
      <p:sp>
        <p:nvSpPr>
          <p:cNvPr id="49" name="TextBox 48">
            <a:extLst>
              <a:ext uri="{FF2B5EF4-FFF2-40B4-BE49-F238E27FC236}">
                <a16:creationId xmlns:a16="http://schemas.microsoft.com/office/drawing/2014/main" id="{18297F73-4326-86D7-D23B-4BCDCAABA05C}"/>
              </a:ext>
            </a:extLst>
          </p:cNvPr>
          <p:cNvSpPr txBox="1"/>
          <p:nvPr/>
        </p:nvSpPr>
        <p:spPr>
          <a:xfrm>
            <a:off x="3238185" y="3663247"/>
            <a:ext cx="4235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ale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CFC57FD-3EC6-5E05-A3F6-D695DAF02A71}"/>
              </a:ext>
            </a:extLst>
          </p:cNvPr>
          <p:cNvSpPr txBox="1"/>
          <p:nvPr/>
        </p:nvSpPr>
        <p:spPr>
          <a:xfrm>
            <a:off x="1957459" y="5924380"/>
            <a:ext cx="6351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AF Status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58B59A6-3146-6FFB-E52B-3595668911A8}"/>
              </a:ext>
            </a:extLst>
          </p:cNvPr>
          <p:cNvSpPr txBox="1"/>
          <p:nvPr/>
        </p:nvSpPr>
        <p:spPr>
          <a:xfrm>
            <a:off x="1215113" y="5924380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29469A1-8BF0-3687-1A74-CB9BE60BEC88}"/>
              </a:ext>
            </a:extLst>
          </p:cNvPr>
          <p:cNvSpPr txBox="1"/>
          <p:nvPr/>
        </p:nvSpPr>
        <p:spPr>
          <a:xfrm>
            <a:off x="2818005" y="5914088"/>
            <a:ext cx="654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</a:p>
          <a:p>
            <a:endParaRPr lang="en-US" sz="900" dirty="0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F52053DE-70BB-5F44-7ACB-3AF9E1675E0D}"/>
              </a:ext>
            </a:extLst>
          </p:cNvPr>
          <p:cNvSpPr/>
          <p:nvPr/>
        </p:nvSpPr>
        <p:spPr>
          <a:xfrm>
            <a:off x="3118552" y="3614282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B8F73717-F31E-D271-F242-1D1C5C330024}"/>
              </a:ext>
            </a:extLst>
          </p:cNvPr>
          <p:cNvSpPr/>
          <p:nvPr/>
        </p:nvSpPr>
        <p:spPr>
          <a:xfrm>
            <a:off x="3118552" y="3750438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2DD4ED"/>
              </a:solidFill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126E70E-4D9A-ED04-6E02-1A4D281F30C5}"/>
              </a:ext>
            </a:extLst>
          </p:cNvPr>
          <p:cNvSpPr txBox="1"/>
          <p:nvPr/>
        </p:nvSpPr>
        <p:spPr>
          <a:xfrm>
            <a:off x="3231425" y="3543917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Female</a:t>
            </a:r>
          </a:p>
        </p:txBody>
      </p:sp>
      <p:pic>
        <p:nvPicPr>
          <p:cNvPr id="57" name="Content Placeholder 6">
            <a:extLst>
              <a:ext uri="{FF2B5EF4-FFF2-40B4-BE49-F238E27FC236}">
                <a16:creationId xmlns:a16="http://schemas.microsoft.com/office/drawing/2014/main" id="{00D7757E-0437-8A89-B810-316A1F233E4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7" r="9776" b="7042"/>
          <a:stretch/>
        </p:blipFill>
        <p:spPr>
          <a:xfrm>
            <a:off x="683074" y="3866320"/>
            <a:ext cx="3189931" cy="2075528"/>
          </a:xfrm>
          <a:prstGeom prst="rect">
            <a:avLst/>
          </a:prstGeom>
        </p:spPr>
      </p:pic>
      <p:sp>
        <p:nvSpPr>
          <p:cNvPr id="58" name="TextBox 57">
            <a:extLst>
              <a:ext uri="{FF2B5EF4-FFF2-40B4-BE49-F238E27FC236}">
                <a16:creationId xmlns:a16="http://schemas.microsoft.com/office/drawing/2014/main" id="{57B2D80A-3892-9C21-3B90-18D810A10408}"/>
              </a:ext>
            </a:extLst>
          </p:cNvPr>
          <p:cNvSpPr txBox="1"/>
          <p:nvPr/>
        </p:nvSpPr>
        <p:spPr>
          <a:xfrm>
            <a:off x="6845277" y="3614282"/>
            <a:ext cx="4235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ale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8DA8C3EB-02C6-2985-14C1-CE0563D18450}"/>
              </a:ext>
            </a:extLst>
          </p:cNvPr>
          <p:cNvSpPr txBox="1"/>
          <p:nvPr/>
        </p:nvSpPr>
        <p:spPr>
          <a:xfrm>
            <a:off x="5542730" y="5983338"/>
            <a:ext cx="6351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AF Status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05ACA357-509C-27A1-399A-577282FBC21A}"/>
              </a:ext>
            </a:extLst>
          </p:cNvPr>
          <p:cNvSpPr txBox="1"/>
          <p:nvPr/>
        </p:nvSpPr>
        <p:spPr>
          <a:xfrm>
            <a:off x="4804994" y="5961421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B54C0EB5-4466-2C72-508F-5917B65F3025}"/>
              </a:ext>
            </a:extLst>
          </p:cNvPr>
          <p:cNvSpPr txBox="1"/>
          <p:nvPr/>
        </p:nvSpPr>
        <p:spPr>
          <a:xfrm>
            <a:off x="6394300" y="5996131"/>
            <a:ext cx="654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</a:p>
          <a:p>
            <a:endParaRPr lang="en-US" sz="900" dirty="0"/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EC4A3A12-EA09-615E-5720-9D07899D7CD5}"/>
              </a:ext>
            </a:extLst>
          </p:cNvPr>
          <p:cNvSpPr/>
          <p:nvPr/>
        </p:nvSpPr>
        <p:spPr>
          <a:xfrm>
            <a:off x="6725644" y="3565317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47057107-FA79-CDCD-F3EA-8DA12B0F8E7B}"/>
              </a:ext>
            </a:extLst>
          </p:cNvPr>
          <p:cNvSpPr/>
          <p:nvPr/>
        </p:nvSpPr>
        <p:spPr>
          <a:xfrm>
            <a:off x="6725644" y="3701473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2DD4ED"/>
              </a:solidFill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08A6314A-8517-25AE-20E9-44F3310E5F6F}"/>
              </a:ext>
            </a:extLst>
          </p:cNvPr>
          <p:cNvSpPr txBox="1"/>
          <p:nvPr/>
        </p:nvSpPr>
        <p:spPr>
          <a:xfrm rot="16200000">
            <a:off x="3922238" y="4787774"/>
            <a:ext cx="50847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3/H4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AEBB346E-DCB1-C27A-7174-8DF1DF693323}"/>
              </a:ext>
            </a:extLst>
          </p:cNvPr>
          <p:cNvSpPr txBox="1"/>
          <p:nvPr/>
        </p:nvSpPr>
        <p:spPr>
          <a:xfrm>
            <a:off x="6838517" y="3494952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Female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855393FC-CFD3-20FF-DA4B-4A918C49DFDA}"/>
              </a:ext>
            </a:extLst>
          </p:cNvPr>
          <p:cNvSpPr txBox="1"/>
          <p:nvPr/>
        </p:nvSpPr>
        <p:spPr>
          <a:xfrm rot="16200000">
            <a:off x="403991" y="4738589"/>
            <a:ext cx="3273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4</a:t>
            </a:r>
          </a:p>
        </p:txBody>
      </p:sp>
      <p:pic>
        <p:nvPicPr>
          <p:cNvPr id="68" name="Content Placeholder 6">
            <a:extLst>
              <a:ext uri="{FF2B5EF4-FFF2-40B4-BE49-F238E27FC236}">
                <a16:creationId xmlns:a16="http://schemas.microsoft.com/office/drawing/2014/main" id="{CE6F3E46-7295-0A3E-A5EE-C7A2174B4426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0" r="10142" b="5140"/>
          <a:stretch/>
        </p:blipFill>
        <p:spPr>
          <a:xfrm>
            <a:off x="4248423" y="3870722"/>
            <a:ext cx="3164661" cy="2165137"/>
          </a:xfrm>
          <a:prstGeom prst="rect">
            <a:avLst/>
          </a:prstGeom>
        </p:spPr>
      </p:pic>
      <p:sp>
        <p:nvSpPr>
          <p:cNvPr id="69" name="TextBox 68">
            <a:extLst>
              <a:ext uri="{FF2B5EF4-FFF2-40B4-BE49-F238E27FC236}">
                <a16:creationId xmlns:a16="http://schemas.microsoft.com/office/drawing/2014/main" id="{A4629DFE-4CEA-CE81-84FF-D7D095F24343}"/>
              </a:ext>
            </a:extLst>
          </p:cNvPr>
          <p:cNvSpPr txBox="1"/>
          <p:nvPr/>
        </p:nvSpPr>
        <p:spPr>
          <a:xfrm>
            <a:off x="10500848" y="3686668"/>
            <a:ext cx="4235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ale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5CD91D22-E524-8E66-E424-73C5B74667CE}"/>
              </a:ext>
            </a:extLst>
          </p:cNvPr>
          <p:cNvSpPr txBox="1"/>
          <p:nvPr/>
        </p:nvSpPr>
        <p:spPr>
          <a:xfrm>
            <a:off x="9315471" y="6120633"/>
            <a:ext cx="6351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AF Status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F2402D86-3398-825C-6AE3-41FEBD7EA5DD}"/>
              </a:ext>
            </a:extLst>
          </p:cNvPr>
          <p:cNvSpPr txBox="1"/>
          <p:nvPr/>
        </p:nvSpPr>
        <p:spPr>
          <a:xfrm>
            <a:off x="8516939" y="6129729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CACCF326-8559-4B31-089B-45AF8DE8BB98}"/>
              </a:ext>
            </a:extLst>
          </p:cNvPr>
          <p:cNvSpPr/>
          <p:nvPr/>
        </p:nvSpPr>
        <p:spPr>
          <a:xfrm>
            <a:off x="10399690" y="3618196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13FF05D6-D1BB-2681-0C6D-867A524EAAB4}"/>
              </a:ext>
            </a:extLst>
          </p:cNvPr>
          <p:cNvSpPr/>
          <p:nvPr/>
        </p:nvSpPr>
        <p:spPr>
          <a:xfrm>
            <a:off x="10399690" y="3754352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2DD4ED"/>
              </a:solidFill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BFAE84E8-D3E3-CECB-5BCA-FD018E28D1ED}"/>
              </a:ext>
            </a:extLst>
          </p:cNvPr>
          <p:cNvSpPr txBox="1"/>
          <p:nvPr/>
        </p:nvSpPr>
        <p:spPr>
          <a:xfrm rot="16200000">
            <a:off x="7518236" y="4908892"/>
            <a:ext cx="77136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acroH2A1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C6EFD562-E3BC-5501-0EBB-89D121E709E5}"/>
              </a:ext>
            </a:extLst>
          </p:cNvPr>
          <p:cNvSpPr txBox="1"/>
          <p:nvPr/>
        </p:nvSpPr>
        <p:spPr>
          <a:xfrm>
            <a:off x="10500848" y="3524278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Female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708220B3-6C65-03BE-C117-60569F17B030}"/>
              </a:ext>
            </a:extLst>
          </p:cNvPr>
          <p:cNvSpPr txBox="1"/>
          <p:nvPr/>
        </p:nvSpPr>
        <p:spPr>
          <a:xfrm>
            <a:off x="10096608" y="6128733"/>
            <a:ext cx="654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</a:p>
          <a:p>
            <a:endParaRPr lang="en-US" sz="900" dirty="0"/>
          </a:p>
        </p:txBody>
      </p:sp>
      <p:pic>
        <p:nvPicPr>
          <p:cNvPr id="78" name="Content Placeholder 6">
            <a:extLst>
              <a:ext uri="{FF2B5EF4-FFF2-40B4-BE49-F238E27FC236}">
                <a16:creationId xmlns:a16="http://schemas.microsoft.com/office/drawing/2014/main" id="{8AC7C74E-E66A-F6A4-4294-DBA214BF8949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3" r="10061" b="7162"/>
          <a:stretch/>
        </p:blipFill>
        <p:spPr>
          <a:xfrm>
            <a:off x="7969655" y="3941741"/>
            <a:ext cx="3334785" cy="21651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18217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56</Words>
  <Application>Microsoft Macintosh PowerPoint</Application>
  <PresentationFormat>Widescreen</PresentationFormat>
  <Paragraphs>4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nlio Vinciguera</dc:creator>
  <cp:lastModifiedBy>Manlio Vinciguera</cp:lastModifiedBy>
  <cp:revision>1</cp:revision>
  <dcterms:created xsi:type="dcterms:W3CDTF">2025-11-02T17:42:31Z</dcterms:created>
  <dcterms:modified xsi:type="dcterms:W3CDTF">2025-11-02T17:45:14Z</dcterms:modified>
</cp:coreProperties>
</file>